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FF3300"/>
    <a:srgbClr val="BF9D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2" autoAdjust="0"/>
    <p:restoredTop sz="94660"/>
  </p:normalViewPr>
  <p:slideViewPr>
    <p:cSldViewPr snapToGrid="0">
      <p:cViewPr varScale="1">
        <p:scale>
          <a:sx n="65" d="100"/>
          <a:sy n="65" d="100"/>
        </p:scale>
        <p:origin x="8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7450CC-EE8A-97BC-E022-F5C3D21386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ADA0CCC-6C44-0691-0843-E63E642CE6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756532-00EA-D8B1-6D19-4CB05E4B6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9B50EE-54BB-B2D9-EFC1-E598CD864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82A64BC-F1FD-AFBC-4524-F2CC9D052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845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1EFCD1-BE42-F405-C8E3-DE35A6491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5413C4F-954A-6C8B-765B-464DF0756D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AFBE895-9E7C-2A51-FB49-7B5A86A6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67DB74-BFB6-51CF-0D08-3A9D868B3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9F1133-289D-E454-ADCC-526CBBD8F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97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3BEDF22-5F25-13AD-4770-BC75C94978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F932E49-6CE7-3BB6-6FEF-981E091749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BE79C75-09C4-4DC9-EC7C-7D4FE0022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E49088-074F-B63E-95CA-75BD09457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55A3C6-2F56-BE4C-D811-604B14E37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51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27E304-ABCF-1DBE-4908-F71A82581A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B797865-332B-2501-D4BC-7FD12B8818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2FD08F8-61F9-B5F4-D815-BC1C36BAB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B74B56-AFA5-D8A3-93FD-8D66CA3AD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B20356-FA79-B6DE-FE95-FA0821AA7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359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8BA66F-B2BA-ECAE-0DD2-2E27ACB53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F897D5E-F843-60C4-CC93-CC5D79BCA7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3461FBB-1EC7-4E4E-C91A-01CD32A80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377475-C428-6CAB-9086-0CB567339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829B74-B22E-E4CD-D1D0-3FC2F9B1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00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AE08D8-65C3-21F4-6BA5-BD574098F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1F7E417-55C5-C315-BE24-FEF4DF854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67F4D8A-B917-A9F3-06AF-1D3BC883A4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BF37E49-32DA-C36A-94A5-C99074109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631E0AF-948D-29CD-D016-68F41680D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63F1A14-63B7-D570-9C46-8B50B017D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13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7760E0-3EED-DB8A-6E98-FE17FA9D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3E44CBB-31FF-972C-1ADA-6B1E6EA86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94F8D2D-5460-F194-90EF-B825FC0D9E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46A3C4E-F97D-6E16-6865-1F1416198D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16947F9-D537-E344-763C-FBF2398B3B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EECA9AC-2E6C-5F59-0320-04BC6E8DE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33578B4-85ED-F44B-6046-2F47B8C9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30C7B59-D4CF-90CB-4F36-99E9A97C3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092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5B9E6F-C566-0CE5-684D-1ECD533BA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B177BEA-0929-BF16-1301-E8F38E58E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9AE3B93-EB5F-B21C-1A01-0F03A5782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485CF85-B630-97F6-ABD1-8FA324480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98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0F73545-FB9D-EBBE-34AE-6C2BC39B0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26137CF-AB7C-6E92-719B-6AC0B815C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5F5D29C-A343-8E74-4A7D-6053E596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2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5807A2-F90B-8954-8BAD-85B878400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825E45C-831C-C901-B065-18A2C61908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0FE3818-03A7-5D99-62B0-45BB5FB2A4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CCD96C-62EE-82CB-0330-E33BC19ED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19472C-127F-3337-672E-3FB266001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CB8BBC4-BF96-93CF-5BB5-557A5C4B2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747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0C3327-069E-5E0E-C803-9207A394F5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5E56E46-F376-4783-00F8-6EDDD24189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1C5EE4D-B6A8-7C34-57C2-649C16153F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29F31A8-ADF3-1D49-E131-E48DCCC7F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04ADDA9-F859-9D77-70FD-7F7938A72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4B2663C-9000-29E0-44B8-666492C8C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98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00A2C98-AB31-4999-97B5-2A57CA47E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944C99F-A629-61D1-58B8-3AF32D36F2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5A4BE7-10BE-D055-CA9A-86C71D103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B27B85-A877-519D-D21A-0ADD5A3C7E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240BCAE-5B96-97C4-38C9-CDAA662E1C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96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84103E-8E5C-769C-5C4B-57C0D2DDAC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ángulo 7">
            <a:extLst>
              <a:ext uri="{FF2B5EF4-FFF2-40B4-BE49-F238E27FC236}">
                <a16:creationId xmlns:a16="http://schemas.microsoft.com/office/drawing/2014/main" id="{E555377E-E63E-A798-2158-174115E75263}"/>
              </a:ext>
            </a:extLst>
          </p:cNvPr>
          <p:cNvSpPr/>
          <p:nvPr/>
        </p:nvSpPr>
        <p:spPr>
          <a:xfrm>
            <a:off x="0" y="0"/>
            <a:ext cx="3540869" cy="6858000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movie3">
            <a:hlinkClick r:id="" action="ppaction://media"/>
            <a:extLst>
              <a:ext uri="{FF2B5EF4-FFF2-40B4-BE49-F238E27FC236}">
                <a16:creationId xmlns:a16="http://schemas.microsoft.com/office/drawing/2014/main" id="{3A15AEEE-7608-E491-62DB-AFCF2B66950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541679" y="449451"/>
            <a:ext cx="8632790" cy="4727480"/>
          </a:xfrm>
          <a:prstGeom prst="rect">
            <a:avLst/>
          </a:prstGeom>
        </p:spPr>
      </p:pic>
      <p:sp>
        <p:nvSpPr>
          <p:cNvPr id="80" name="CuadroTexto 79">
            <a:extLst/>
          </p:cNvPr>
          <p:cNvSpPr txBox="1"/>
          <p:nvPr/>
        </p:nvSpPr>
        <p:spPr>
          <a:xfrm>
            <a:off x="392850" y="4827418"/>
            <a:ext cx="310244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tiary structure view</a:t>
            </a:r>
          </a:p>
        </p:txBody>
      </p:sp>
      <p:grpSp>
        <p:nvGrpSpPr>
          <p:cNvPr id="81" name="Grupo 80"/>
          <p:cNvGrpSpPr/>
          <p:nvPr/>
        </p:nvGrpSpPr>
        <p:grpSpPr>
          <a:xfrm>
            <a:off x="5816415" y="203888"/>
            <a:ext cx="3355750" cy="495853"/>
            <a:chOff x="5816415" y="203888"/>
            <a:chExt cx="3355750" cy="495853"/>
          </a:xfrm>
        </p:grpSpPr>
        <p:pic>
          <p:nvPicPr>
            <p:cNvPr id="82" name="Imagen 8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16415" y="203888"/>
              <a:ext cx="3355750" cy="256209"/>
            </a:xfrm>
            <a:prstGeom prst="rect">
              <a:avLst/>
            </a:prstGeom>
          </p:spPr>
        </p:pic>
        <p:grpSp>
          <p:nvGrpSpPr>
            <p:cNvPr id="83" name="Grupo 82"/>
            <p:cNvGrpSpPr/>
            <p:nvPr/>
          </p:nvGrpSpPr>
          <p:grpSpPr>
            <a:xfrm>
              <a:off x="6217839" y="348034"/>
              <a:ext cx="2700451" cy="351707"/>
              <a:chOff x="7172410" y="110944"/>
              <a:chExt cx="2089635" cy="272154"/>
            </a:xfrm>
          </p:grpSpPr>
          <p:sp>
            <p:nvSpPr>
              <p:cNvPr id="84" name="CuadroTexto 83">
                <a:extLst/>
              </p:cNvPr>
              <p:cNvSpPr txBox="1"/>
              <p:nvPr/>
            </p:nvSpPr>
            <p:spPr>
              <a:xfrm>
                <a:off x="8797897" y="110944"/>
                <a:ext cx="464148" cy="2099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116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831 </a:t>
                </a:r>
                <a:endParaRPr lang="es-AR" sz="11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CuadroTexto 84"/>
              <p:cNvSpPr txBox="1"/>
              <p:nvPr/>
            </p:nvSpPr>
            <p:spPr>
              <a:xfrm>
                <a:off x="7172410" y="142308"/>
                <a:ext cx="1769085" cy="2407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1422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tromyzon</a:t>
                </a:r>
                <a:r>
                  <a:rPr lang="es-AR" sz="1422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422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inus</a:t>
                </a:r>
                <a:r>
                  <a:rPr lang="es-AR" sz="1422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42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G</a:t>
                </a:r>
                <a:endParaRPr lang="es-AR" sz="3108" dirty="0"/>
              </a:p>
            </p:txBody>
          </p:sp>
        </p:grpSp>
      </p:grpSp>
      <p:grpSp>
        <p:nvGrpSpPr>
          <p:cNvPr id="86" name="Grupo 85"/>
          <p:cNvGrpSpPr/>
          <p:nvPr/>
        </p:nvGrpSpPr>
        <p:grpSpPr>
          <a:xfrm>
            <a:off x="5855889" y="6107260"/>
            <a:ext cx="3355750" cy="576220"/>
            <a:chOff x="5855889" y="6107260"/>
            <a:chExt cx="3355750" cy="576220"/>
          </a:xfrm>
        </p:grpSpPr>
        <p:pic>
          <p:nvPicPr>
            <p:cNvPr id="87" name="Imagen 8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55889" y="6107260"/>
              <a:ext cx="3355750" cy="265045"/>
            </a:xfrm>
            <a:prstGeom prst="rect">
              <a:avLst/>
            </a:prstGeom>
          </p:spPr>
        </p:pic>
        <p:sp>
          <p:nvSpPr>
            <p:cNvPr id="88" name="CuadroTexto 87">
              <a:extLst/>
            </p:cNvPr>
            <p:cNvSpPr txBox="1"/>
            <p:nvPr/>
          </p:nvSpPr>
          <p:spPr>
            <a:xfrm>
              <a:off x="6593380" y="6372305"/>
              <a:ext cx="2134410" cy="3111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1422" b="1" i="1" dirty="0">
                  <a:latin typeface="Arial" panose="020B0604020202020204" pitchFamily="34" charset="0"/>
                  <a:cs typeface="Arial" panose="020B0604020202020204" pitchFamily="34" charset="0"/>
                </a:rPr>
                <a:t>Homo sapiens </a:t>
              </a:r>
              <a:r>
                <a:rPr lang="es-ES" sz="1422" b="1" dirty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s-AR" sz="142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CuadroTexto 91"/>
          <p:cNvSpPr txBox="1"/>
          <p:nvPr/>
        </p:nvSpPr>
        <p:spPr>
          <a:xfrm>
            <a:off x="-2203" y="2205169"/>
            <a:ext cx="3595856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tromyzon</a:t>
            </a:r>
            <a:r>
              <a:rPr lang="es-AR" sz="20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inus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31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AR" dirty="0"/>
          </a:p>
        </p:txBody>
      </p:sp>
      <p:sp>
        <p:nvSpPr>
          <p:cNvPr id="93" name="CuadroTexto 92">
            <a:extLst/>
          </p:cNvPr>
          <p:cNvSpPr txBox="1"/>
          <p:nvPr/>
        </p:nvSpPr>
        <p:spPr>
          <a:xfrm>
            <a:off x="477426" y="3454737"/>
            <a:ext cx="243361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0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 sapiens </a:t>
            </a:r>
            <a:r>
              <a:rPr lang="es-E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uadroTexto 94"/>
          <p:cNvSpPr txBox="1"/>
          <p:nvPr/>
        </p:nvSpPr>
        <p:spPr>
          <a:xfrm>
            <a:off x="1271578" y="2863647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</a:p>
        </p:txBody>
      </p:sp>
      <p:sp>
        <p:nvSpPr>
          <p:cNvPr id="96" name="CuadroTexto 95"/>
          <p:cNvSpPr txBox="1"/>
          <p:nvPr/>
        </p:nvSpPr>
        <p:spPr>
          <a:xfrm>
            <a:off x="846331" y="1521744"/>
            <a:ext cx="16658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chMaker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51938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19</Words>
  <Application>Microsoft Office PowerPoint</Application>
  <PresentationFormat>Panorámica</PresentationFormat>
  <Paragraphs>8</Paragraphs>
  <Slides>1</Slides>
  <Notes>0</Notes>
  <HiddenSlides>0</HiddenSlides>
  <MMClips>1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Gomes</dc:creator>
  <cp:lastModifiedBy>Héctor Targovnik</cp:lastModifiedBy>
  <cp:revision>25</cp:revision>
  <dcterms:created xsi:type="dcterms:W3CDTF">2025-02-27T19:49:07Z</dcterms:created>
  <dcterms:modified xsi:type="dcterms:W3CDTF">2025-04-02T23:24:08Z</dcterms:modified>
</cp:coreProperties>
</file>